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389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esktop\Sup%203%20R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esktop\Sup%203%20R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3!$A$2</c:f>
              <c:strCache>
                <c:ptCount val="1"/>
                <c:pt idx="0">
                  <c:v>Desulfobacteracea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2:$Y$2</c:f>
              <c:numCache>
                <c:formatCode>General</c:formatCode>
                <c:ptCount val="24"/>
                <c:pt idx="0">
                  <c:v>13.036906411386825</c:v>
                </c:pt>
                <c:pt idx="1">
                  <c:v>12.928293889085129</c:v>
                </c:pt>
                <c:pt idx="2">
                  <c:v>3.4445640473627557</c:v>
                </c:pt>
                <c:pt idx="3">
                  <c:v>16.894409937888199</c:v>
                </c:pt>
                <c:pt idx="5">
                  <c:v>18.959456292477149</c:v>
                </c:pt>
                <c:pt idx="6">
                  <c:v>15.471112834431951</c:v>
                </c:pt>
                <c:pt idx="7">
                  <c:v>19.312169312169313</c:v>
                </c:pt>
                <c:pt idx="8">
                  <c:v>19.811320754716981</c:v>
                </c:pt>
                <c:pt idx="9">
                  <c:v>19.573901464713714</c:v>
                </c:pt>
                <c:pt idx="11">
                  <c:v>19.41919191919192</c:v>
                </c:pt>
                <c:pt idx="12">
                  <c:v>13.482142857142858</c:v>
                </c:pt>
                <c:pt idx="13">
                  <c:v>14.761092150170649</c:v>
                </c:pt>
                <c:pt idx="14">
                  <c:v>19.106699751861044</c:v>
                </c:pt>
                <c:pt idx="15">
                  <c:v>13.86430678</c:v>
                </c:pt>
                <c:pt idx="17">
                  <c:v>16.13466836906122</c:v>
                </c:pt>
                <c:pt idx="18">
                  <c:v>10.597302504816955</c:v>
                </c:pt>
                <c:pt idx="19">
                  <c:v>11.608300907911802</c:v>
                </c:pt>
                <c:pt idx="21">
                  <c:v>28.49702380952381</c:v>
                </c:pt>
                <c:pt idx="22">
                  <c:v>20.11888431641518</c:v>
                </c:pt>
                <c:pt idx="23">
                  <c:v>17.017954719999999</c:v>
                </c:pt>
              </c:numCache>
            </c:numRef>
          </c:val>
        </c:ser>
        <c:ser>
          <c:idx val="1"/>
          <c:order val="1"/>
          <c:tx>
            <c:strRef>
              <c:f>Sheet3!$A$3</c:f>
              <c:strCache>
                <c:ptCount val="1"/>
                <c:pt idx="0">
                  <c:v>Desulfobulbacea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3:$Y$3</c:f>
              <c:numCache>
                <c:formatCode>General</c:formatCode>
                <c:ptCount val="24"/>
                <c:pt idx="0">
                  <c:v>4.3582315153041948</c:v>
                </c:pt>
                <c:pt idx="1">
                  <c:v>3.4263511126810315</c:v>
                </c:pt>
                <c:pt idx="2">
                  <c:v>0.43057050592034446</c:v>
                </c:pt>
                <c:pt idx="3">
                  <c:v>16.149068322981368</c:v>
                </c:pt>
                <c:pt idx="5">
                  <c:v>17.342395125380829</c:v>
                </c:pt>
                <c:pt idx="6">
                  <c:v>18.301667312911981</c:v>
                </c:pt>
                <c:pt idx="7">
                  <c:v>13.624338624338625</c:v>
                </c:pt>
                <c:pt idx="8">
                  <c:v>7.8616352201257858</c:v>
                </c:pt>
                <c:pt idx="9">
                  <c:v>14.824678206835332</c:v>
                </c:pt>
                <c:pt idx="11">
                  <c:v>7.6767676767676765</c:v>
                </c:pt>
                <c:pt idx="12">
                  <c:v>10.178571428571429</c:v>
                </c:pt>
                <c:pt idx="13">
                  <c:v>7.0819112627986351</c:v>
                </c:pt>
                <c:pt idx="14">
                  <c:v>4.9627791563275432</c:v>
                </c:pt>
                <c:pt idx="15">
                  <c:v>14.74926254</c:v>
                </c:pt>
                <c:pt idx="17">
                  <c:v>15.200591358107655</c:v>
                </c:pt>
                <c:pt idx="18">
                  <c:v>3.0828516377649327</c:v>
                </c:pt>
                <c:pt idx="19">
                  <c:v>14.785992217898833</c:v>
                </c:pt>
                <c:pt idx="21">
                  <c:v>14.16170634920635</c:v>
                </c:pt>
                <c:pt idx="22">
                  <c:v>7.0873342478280748</c:v>
                </c:pt>
                <c:pt idx="23">
                  <c:v>7.6502732240000002</c:v>
                </c:pt>
              </c:numCache>
            </c:numRef>
          </c:val>
        </c:ser>
        <c:ser>
          <c:idx val="2"/>
          <c:order val="2"/>
          <c:tx>
            <c:strRef>
              <c:f>Sheet3!$A$4</c:f>
              <c:strCache>
                <c:ptCount val="1"/>
                <c:pt idx="0">
                  <c:v>Hyphomicrobiacea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4:$Y$4</c:f>
              <c:numCache>
                <c:formatCode>General</c:formatCode>
                <c:ptCount val="24"/>
                <c:pt idx="0">
                  <c:v>11.852878196246378</c:v>
                </c:pt>
                <c:pt idx="1">
                  <c:v>15.930766513599435</c:v>
                </c:pt>
                <c:pt idx="2">
                  <c:v>6.8891280947255114</c:v>
                </c:pt>
                <c:pt idx="3">
                  <c:v>10.559006211180124</c:v>
                </c:pt>
                <c:pt idx="5">
                  <c:v>4.4059057886102648</c:v>
                </c:pt>
                <c:pt idx="6">
                  <c:v>7.1733229934082976</c:v>
                </c:pt>
                <c:pt idx="7">
                  <c:v>6.0846560846560847</c:v>
                </c:pt>
                <c:pt idx="8">
                  <c:v>4.4025157232704402</c:v>
                </c:pt>
                <c:pt idx="9">
                  <c:v>4.5716822015090992</c:v>
                </c:pt>
                <c:pt idx="11">
                  <c:v>3.0555555555555554</c:v>
                </c:pt>
                <c:pt idx="12">
                  <c:v>4.4196428571428568</c:v>
                </c:pt>
                <c:pt idx="13">
                  <c:v>3.2849829351535837</c:v>
                </c:pt>
                <c:pt idx="14">
                  <c:v>4.9627791563275432</c:v>
                </c:pt>
                <c:pt idx="15">
                  <c:v>8.2595870209999998</c:v>
                </c:pt>
                <c:pt idx="17">
                  <c:v>6.0681405819501375</c:v>
                </c:pt>
                <c:pt idx="18">
                  <c:v>4.4315992292870909</c:v>
                </c:pt>
                <c:pt idx="19">
                  <c:v>7.911802853437095</c:v>
                </c:pt>
                <c:pt idx="21">
                  <c:v>6.0639880952380949</c:v>
                </c:pt>
                <c:pt idx="22">
                  <c:v>7.9103795153177865</c:v>
                </c:pt>
                <c:pt idx="23">
                  <c:v>4.9180327869999996</c:v>
                </c:pt>
              </c:numCache>
            </c:numRef>
          </c:val>
        </c:ser>
        <c:ser>
          <c:idx val="3"/>
          <c:order val="3"/>
          <c:tx>
            <c:strRef>
              <c:f>Sheet3!$A$5</c:f>
              <c:strCache>
                <c:ptCount val="1"/>
                <c:pt idx="0">
                  <c:v>Piscirickettsiacea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5:$Y$5</c:f>
              <c:numCache>
                <c:formatCode>General</c:formatCode>
                <c:ptCount val="24"/>
                <c:pt idx="0">
                  <c:v>1.3225847084015618</c:v>
                </c:pt>
                <c:pt idx="1">
                  <c:v>2.3313316849169903</c:v>
                </c:pt>
                <c:pt idx="2">
                  <c:v>0.10764262648008611</c:v>
                </c:pt>
                <c:pt idx="3">
                  <c:v>4.5962732919254661</c:v>
                </c:pt>
                <c:pt idx="5">
                  <c:v>6.9603937192406846</c:v>
                </c:pt>
                <c:pt idx="6">
                  <c:v>7.5610701822411785</c:v>
                </c:pt>
                <c:pt idx="7">
                  <c:v>11.054421768707483</c:v>
                </c:pt>
                <c:pt idx="8">
                  <c:v>7.5471698113207548</c:v>
                </c:pt>
                <c:pt idx="9">
                  <c:v>11.051930758988016</c:v>
                </c:pt>
                <c:pt idx="11">
                  <c:v>15.126262626262626</c:v>
                </c:pt>
                <c:pt idx="12">
                  <c:v>14.151785714285714</c:v>
                </c:pt>
                <c:pt idx="13">
                  <c:v>11.220136518771332</c:v>
                </c:pt>
                <c:pt idx="14">
                  <c:v>5.9553349875930524</c:v>
                </c:pt>
                <c:pt idx="15">
                  <c:v>5.7522123890000003</c:v>
                </c:pt>
                <c:pt idx="17">
                  <c:v>1.6262347960486527</c:v>
                </c:pt>
                <c:pt idx="18">
                  <c:v>9.2485549132947984</c:v>
                </c:pt>
                <c:pt idx="19">
                  <c:v>4.3450064850843058</c:v>
                </c:pt>
                <c:pt idx="21">
                  <c:v>1.7733134920634921</c:v>
                </c:pt>
                <c:pt idx="22">
                  <c:v>1.005944215820759</c:v>
                </c:pt>
                <c:pt idx="23">
                  <c:v>9.3676814989999997</c:v>
                </c:pt>
              </c:numCache>
            </c:numRef>
          </c:val>
        </c:ser>
        <c:ser>
          <c:idx val="4"/>
          <c:order val="4"/>
          <c:tx>
            <c:strRef>
              <c:f>Sheet3!$A$6</c:f>
              <c:strCache>
                <c:ptCount val="1"/>
                <c:pt idx="0">
                  <c:v>Rhodobacteracea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6:$Y$6</c:f>
              <c:numCache>
                <c:formatCode>General</c:formatCode>
                <c:ptCount val="24"/>
                <c:pt idx="0">
                  <c:v>6.8900365285300413</c:v>
                </c:pt>
                <c:pt idx="1">
                  <c:v>13.811374072765807</c:v>
                </c:pt>
                <c:pt idx="2">
                  <c:v>6.4585575888051672</c:v>
                </c:pt>
                <c:pt idx="3">
                  <c:v>5.341614906832298</c:v>
                </c:pt>
                <c:pt idx="5">
                  <c:v>5.4136395594094209</c:v>
                </c:pt>
                <c:pt idx="6">
                  <c:v>4.9631640170608762</c:v>
                </c:pt>
                <c:pt idx="7">
                  <c:v>3.6848072562358278</c:v>
                </c:pt>
                <c:pt idx="8">
                  <c:v>11.0062893081761</c:v>
                </c:pt>
                <c:pt idx="9">
                  <c:v>2.3080337328007103</c:v>
                </c:pt>
                <c:pt idx="11">
                  <c:v>5.4545454545454541</c:v>
                </c:pt>
                <c:pt idx="12">
                  <c:v>6.4732142857142856</c:v>
                </c:pt>
                <c:pt idx="13">
                  <c:v>10.83617747440273</c:v>
                </c:pt>
                <c:pt idx="14">
                  <c:v>5.7071960297766751</c:v>
                </c:pt>
                <c:pt idx="15">
                  <c:v>3.9823008849999999</c:v>
                </c:pt>
                <c:pt idx="17">
                  <c:v>7.338216517707143</c:v>
                </c:pt>
                <c:pt idx="18">
                  <c:v>4.2389210019267827</c:v>
                </c:pt>
                <c:pt idx="19">
                  <c:v>4.2801556420233462</c:v>
                </c:pt>
                <c:pt idx="21">
                  <c:v>0.6696428571428571</c:v>
                </c:pt>
                <c:pt idx="22">
                  <c:v>8.5048010973936901</c:v>
                </c:pt>
                <c:pt idx="23">
                  <c:v>9.2896174859999991</c:v>
                </c:pt>
              </c:numCache>
            </c:numRef>
          </c:val>
        </c:ser>
        <c:ser>
          <c:idx val="5"/>
          <c:order val="5"/>
          <c:tx>
            <c:strRef>
              <c:f>Sheet3!$A$7</c:f>
              <c:strCache>
                <c:ptCount val="1"/>
                <c:pt idx="0">
                  <c:v>Desulfarculacea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7:$Y$7</c:f>
              <c:numCache>
                <c:formatCode>General</c:formatCode>
                <c:ptCount val="24"/>
                <c:pt idx="0">
                  <c:v>3.2497795692152662</c:v>
                </c:pt>
                <c:pt idx="1">
                  <c:v>2.9671494171670787</c:v>
                </c:pt>
                <c:pt idx="2">
                  <c:v>0.64585575888051672</c:v>
                </c:pt>
                <c:pt idx="3">
                  <c:v>4.2236024844720497</c:v>
                </c:pt>
                <c:pt idx="5">
                  <c:v>4.9214905085540188</c:v>
                </c:pt>
                <c:pt idx="6">
                  <c:v>3.1019775106630476</c:v>
                </c:pt>
                <c:pt idx="7">
                  <c:v>4.2705971277399852</c:v>
                </c:pt>
                <c:pt idx="8">
                  <c:v>4.4025157232704402</c:v>
                </c:pt>
                <c:pt idx="9">
                  <c:v>5.0155348424323121</c:v>
                </c:pt>
                <c:pt idx="11">
                  <c:v>4.5707070707070709</c:v>
                </c:pt>
                <c:pt idx="12">
                  <c:v>3.8839285714285716</c:v>
                </c:pt>
                <c:pt idx="13">
                  <c:v>4.1382252559726966</c:v>
                </c:pt>
                <c:pt idx="14">
                  <c:v>0.99255583126550873</c:v>
                </c:pt>
                <c:pt idx="15">
                  <c:v>4.2772861359999998</c:v>
                </c:pt>
                <c:pt idx="17">
                  <c:v>5.0063839795712655</c:v>
                </c:pt>
                <c:pt idx="18">
                  <c:v>3.2755298651252409</c:v>
                </c:pt>
                <c:pt idx="19">
                  <c:v>1.880674448767834</c:v>
                </c:pt>
                <c:pt idx="21">
                  <c:v>7.8621031746031749</c:v>
                </c:pt>
                <c:pt idx="22">
                  <c:v>5.9442158207590303</c:v>
                </c:pt>
                <c:pt idx="23">
                  <c:v>3.4348165499999999</c:v>
                </c:pt>
              </c:numCache>
            </c:numRef>
          </c:val>
        </c:ser>
        <c:ser>
          <c:idx val="6"/>
          <c:order val="6"/>
          <c:tx>
            <c:strRef>
              <c:f>Sheet3!$A$8</c:f>
              <c:strCache>
                <c:ptCount val="1"/>
                <c:pt idx="0">
                  <c:v>Ignavibacteriaceae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8:$Y$8</c:f>
              <c:numCache>
                <c:formatCode>General</c:formatCode>
                <c:ptCount val="24"/>
                <c:pt idx="0">
                  <c:v>7.4694545912583452</c:v>
                </c:pt>
                <c:pt idx="1">
                  <c:v>5.3338043094312964</c:v>
                </c:pt>
                <c:pt idx="2">
                  <c:v>4.1980624327233587</c:v>
                </c:pt>
                <c:pt idx="3">
                  <c:v>3.7267080745341614</c:v>
                </c:pt>
                <c:pt idx="5">
                  <c:v>3.3981720178111083</c:v>
                </c:pt>
                <c:pt idx="6">
                  <c:v>2.4815820085304381</c:v>
                </c:pt>
                <c:pt idx="7">
                  <c:v>2.6643990929705215</c:v>
                </c:pt>
                <c:pt idx="8">
                  <c:v>1.5723270440251573</c:v>
                </c:pt>
                <c:pt idx="9">
                  <c:v>3.5952063914780292</c:v>
                </c:pt>
                <c:pt idx="11">
                  <c:v>1.792929292929293</c:v>
                </c:pt>
                <c:pt idx="12">
                  <c:v>3.3482142857142856</c:v>
                </c:pt>
                <c:pt idx="13">
                  <c:v>1.4789533560864618</c:v>
                </c:pt>
                <c:pt idx="14">
                  <c:v>2.7295285359801489</c:v>
                </c:pt>
                <c:pt idx="15">
                  <c:v>7.5221238939999999</c:v>
                </c:pt>
                <c:pt idx="17">
                  <c:v>5.187823398965123</c:v>
                </c:pt>
                <c:pt idx="18">
                  <c:v>2.8901734104046244</c:v>
                </c:pt>
                <c:pt idx="19">
                  <c:v>2.4643320363164722</c:v>
                </c:pt>
                <c:pt idx="21">
                  <c:v>4.1418650793650791</c:v>
                </c:pt>
                <c:pt idx="22">
                  <c:v>6.9501600365797893</c:v>
                </c:pt>
                <c:pt idx="23">
                  <c:v>1.4051522249999999</c:v>
                </c:pt>
              </c:numCache>
            </c:numRef>
          </c:val>
        </c:ser>
        <c:ser>
          <c:idx val="7"/>
          <c:order val="7"/>
          <c:tx>
            <c:strRef>
              <c:f>Sheet3!$A$9</c:f>
              <c:strCache>
                <c:ptCount val="1"/>
                <c:pt idx="0">
                  <c:v>Mariprofundaceae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9:$Y$9</c:f>
              <c:numCache>
                <c:formatCode>General</c:formatCode>
                <c:ptCount val="24"/>
                <c:pt idx="0">
                  <c:v>12.583448797077718</c:v>
                </c:pt>
                <c:pt idx="1">
                  <c:v>8.4422465559872837</c:v>
                </c:pt>
                <c:pt idx="2">
                  <c:v>10.979547900968784</c:v>
                </c:pt>
                <c:pt idx="3">
                  <c:v>2.4844720496894408</c:v>
                </c:pt>
                <c:pt idx="5">
                  <c:v>0.82024841809233651</c:v>
                </c:pt>
                <c:pt idx="6">
                  <c:v>1.1244668476153548</c:v>
                </c:pt>
                <c:pt idx="7">
                  <c:v>1.436130007558579</c:v>
                </c:pt>
                <c:pt idx="8">
                  <c:v>0.94339622641509435</c:v>
                </c:pt>
                <c:pt idx="9">
                  <c:v>0.66577896138482029</c:v>
                </c:pt>
                <c:pt idx="11">
                  <c:v>0.20202020202020202</c:v>
                </c:pt>
                <c:pt idx="12">
                  <c:v>1.1160714285714286</c:v>
                </c:pt>
                <c:pt idx="13">
                  <c:v>0.31285551763367464</c:v>
                </c:pt>
                <c:pt idx="14">
                  <c:v>6.4516129032258061</c:v>
                </c:pt>
                <c:pt idx="15">
                  <c:v>2.2123893809999999</c:v>
                </c:pt>
                <c:pt idx="17">
                  <c:v>4.394865936429003</c:v>
                </c:pt>
                <c:pt idx="18">
                  <c:v>5.5876685934489405</c:v>
                </c:pt>
                <c:pt idx="19">
                  <c:v>4.4098573281452662</c:v>
                </c:pt>
                <c:pt idx="21">
                  <c:v>0.53323412698412698</c:v>
                </c:pt>
                <c:pt idx="22">
                  <c:v>6.4471879286694103</c:v>
                </c:pt>
                <c:pt idx="23">
                  <c:v>1.327088212</c:v>
                </c:pt>
              </c:numCache>
            </c:numRef>
          </c:val>
        </c:ser>
        <c:ser>
          <c:idx val="8"/>
          <c:order val="8"/>
          <c:tx>
            <c:strRef>
              <c:f>Sheet3!$A$10</c:f>
              <c:strCache>
                <c:ptCount val="1"/>
                <c:pt idx="0">
                  <c:v>Helicobacteraceae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10:$Y$10</c:f>
              <c:numCache>
                <c:formatCode>General</c:formatCode>
                <c:ptCount val="24"/>
                <c:pt idx="0">
                  <c:v>0.86912709409245492</c:v>
                </c:pt>
                <c:pt idx="1">
                  <c:v>1.0596962204168139</c:v>
                </c:pt>
                <c:pt idx="2">
                  <c:v>0</c:v>
                </c:pt>
                <c:pt idx="3">
                  <c:v>2.8571428571428572</c:v>
                </c:pt>
                <c:pt idx="5">
                  <c:v>2.6482306069838293</c:v>
                </c:pt>
                <c:pt idx="6">
                  <c:v>3.7223730127956571</c:v>
                </c:pt>
                <c:pt idx="7">
                  <c:v>1.3794406651549509</c:v>
                </c:pt>
                <c:pt idx="8">
                  <c:v>0</c:v>
                </c:pt>
                <c:pt idx="9">
                  <c:v>1.6866400355082112</c:v>
                </c:pt>
                <c:pt idx="11">
                  <c:v>0.95959595959595956</c:v>
                </c:pt>
                <c:pt idx="12">
                  <c:v>3.75</c:v>
                </c:pt>
                <c:pt idx="13">
                  <c:v>5.1905574516496022</c:v>
                </c:pt>
                <c:pt idx="14">
                  <c:v>0.49627791563275436</c:v>
                </c:pt>
                <c:pt idx="15">
                  <c:v>3.539823009</c:v>
                </c:pt>
                <c:pt idx="17">
                  <c:v>5.187823398965123</c:v>
                </c:pt>
                <c:pt idx="18">
                  <c:v>0</c:v>
                </c:pt>
                <c:pt idx="19">
                  <c:v>5.0583657587548636</c:v>
                </c:pt>
                <c:pt idx="21">
                  <c:v>11.941964285714286</c:v>
                </c:pt>
                <c:pt idx="22">
                  <c:v>8.5962505715592137</c:v>
                </c:pt>
                <c:pt idx="23">
                  <c:v>0.46838407500000001</c:v>
                </c:pt>
              </c:numCache>
            </c:numRef>
          </c:val>
        </c:ser>
        <c:ser>
          <c:idx val="9"/>
          <c:order val="9"/>
          <c:tx>
            <c:strRef>
              <c:f>Sheet3!$A$11</c:f>
              <c:strCache>
                <c:ptCount val="1"/>
                <c:pt idx="0">
                  <c:v>Xanthomonadaceae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11:$Y$11</c:f>
              <c:numCache>
                <c:formatCode>General</c:formatCode>
                <c:ptCount val="24"/>
                <c:pt idx="0">
                  <c:v>3.9425620355208464</c:v>
                </c:pt>
                <c:pt idx="1">
                  <c:v>2.4726245143058989</c:v>
                </c:pt>
                <c:pt idx="2">
                  <c:v>11.517761033369215</c:v>
                </c:pt>
                <c:pt idx="3">
                  <c:v>0.49689440993788819</c:v>
                </c:pt>
                <c:pt idx="5">
                  <c:v>9.3742676353409896E-2</c:v>
                </c:pt>
                <c:pt idx="6">
                  <c:v>0.23264831329972857</c:v>
                </c:pt>
                <c:pt idx="7">
                  <c:v>0.17006802721088435</c:v>
                </c:pt>
                <c:pt idx="8">
                  <c:v>8.1761006289308185</c:v>
                </c:pt>
                <c:pt idx="9">
                  <c:v>0.13315579227696406</c:v>
                </c:pt>
                <c:pt idx="11">
                  <c:v>5.0505050505050504E-2</c:v>
                </c:pt>
                <c:pt idx="12">
                  <c:v>4.4642857142857144E-2</c:v>
                </c:pt>
                <c:pt idx="13">
                  <c:v>2.9152445961319682</c:v>
                </c:pt>
                <c:pt idx="14">
                  <c:v>5.2109181141439205</c:v>
                </c:pt>
                <c:pt idx="15">
                  <c:v>3.0973451330000001</c:v>
                </c:pt>
                <c:pt idx="17">
                  <c:v>0.65855789261474362</c:v>
                </c:pt>
                <c:pt idx="18">
                  <c:v>5.973025048169557</c:v>
                </c:pt>
                <c:pt idx="19">
                  <c:v>0.45395590142671854</c:v>
                </c:pt>
                <c:pt idx="21">
                  <c:v>4.96031746031746E-2</c:v>
                </c:pt>
                <c:pt idx="22">
                  <c:v>0.96021947873799729</c:v>
                </c:pt>
                <c:pt idx="23">
                  <c:v>8.8212334109999997</c:v>
                </c:pt>
              </c:numCache>
            </c:numRef>
          </c:val>
        </c:ser>
        <c:ser>
          <c:idx val="10"/>
          <c:order val="10"/>
          <c:tx>
            <c:strRef>
              <c:f>Sheet3!$A$12</c:f>
              <c:strCache>
                <c:ptCount val="1"/>
                <c:pt idx="0">
                  <c:v>Syntrophobacteraceae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12:$Y$12</c:f>
              <c:numCache>
                <c:formatCode>General</c:formatCode>
                <c:ptCount val="24"/>
                <c:pt idx="0">
                  <c:v>1.4485451568207584</c:v>
                </c:pt>
                <c:pt idx="1">
                  <c:v>2.8965030024726244</c:v>
                </c:pt>
                <c:pt idx="2">
                  <c:v>0.64585575888051672</c:v>
                </c:pt>
                <c:pt idx="3">
                  <c:v>1.4906832298136645</c:v>
                </c:pt>
                <c:pt idx="5">
                  <c:v>2.5076165924537146</c:v>
                </c:pt>
                <c:pt idx="6">
                  <c:v>2.1326095385808452</c:v>
                </c:pt>
                <c:pt idx="7">
                  <c:v>5.3476946334089188</c:v>
                </c:pt>
                <c:pt idx="8">
                  <c:v>3.1446540880503147</c:v>
                </c:pt>
                <c:pt idx="9">
                  <c:v>4.7492232578783842</c:v>
                </c:pt>
                <c:pt idx="11">
                  <c:v>3.5606060606060606</c:v>
                </c:pt>
                <c:pt idx="12">
                  <c:v>3.9732142857142856</c:v>
                </c:pt>
                <c:pt idx="13">
                  <c:v>5.5460750853242322</c:v>
                </c:pt>
                <c:pt idx="14">
                  <c:v>2.9776674937965262</c:v>
                </c:pt>
                <c:pt idx="15">
                  <c:v>2.2123893809999999</c:v>
                </c:pt>
                <c:pt idx="17">
                  <c:v>1.2499160002687992</c:v>
                </c:pt>
                <c:pt idx="18">
                  <c:v>1.7341040462427746</c:v>
                </c:pt>
                <c:pt idx="19">
                  <c:v>1.7509727626459144</c:v>
                </c:pt>
                <c:pt idx="21">
                  <c:v>3.0133928571428572</c:v>
                </c:pt>
                <c:pt idx="22">
                  <c:v>1.2802926383173296</c:v>
                </c:pt>
                <c:pt idx="23">
                  <c:v>2.2638563619999998</c:v>
                </c:pt>
              </c:numCache>
            </c:numRef>
          </c:val>
        </c:ser>
        <c:ser>
          <c:idx val="11"/>
          <c:order val="11"/>
          <c:tx>
            <c:strRef>
              <c:f>Sheet3!$A$13</c:f>
              <c:strCache>
                <c:ptCount val="1"/>
                <c:pt idx="0">
                  <c:v>Ectothiorhodospiraceae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13:$Y$13</c:f>
              <c:numCache>
                <c:formatCode>General</c:formatCode>
                <c:ptCount val="24"/>
                <c:pt idx="0">
                  <c:v>1.8264265020783474</c:v>
                </c:pt>
                <c:pt idx="1">
                  <c:v>1.7308371600141292</c:v>
                </c:pt>
                <c:pt idx="2">
                  <c:v>9.6878363832077508</c:v>
                </c:pt>
                <c:pt idx="3">
                  <c:v>0.99378881987577639</c:v>
                </c:pt>
                <c:pt idx="5">
                  <c:v>1.8982891961565502</c:v>
                </c:pt>
                <c:pt idx="6">
                  <c:v>1.5897634742148119</c:v>
                </c:pt>
                <c:pt idx="7">
                  <c:v>1.4550264550264551</c:v>
                </c:pt>
                <c:pt idx="8">
                  <c:v>0.94339622641509435</c:v>
                </c:pt>
                <c:pt idx="9">
                  <c:v>2.0861074123391035</c:v>
                </c:pt>
                <c:pt idx="11">
                  <c:v>2.0454545454545454</c:v>
                </c:pt>
                <c:pt idx="12">
                  <c:v>2.0535714285714284</c:v>
                </c:pt>
                <c:pt idx="13">
                  <c:v>2.033560864618885</c:v>
                </c:pt>
                <c:pt idx="14">
                  <c:v>5.4590570719602978</c:v>
                </c:pt>
                <c:pt idx="15">
                  <c:v>2.3598820059999999</c:v>
                </c:pt>
                <c:pt idx="17">
                  <c:v>0.85343726900073924</c:v>
                </c:pt>
                <c:pt idx="18">
                  <c:v>6.9364161849710984</c:v>
                </c:pt>
                <c:pt idx="19">
                  <c:v>0.71335927367055774</c:v>
                </c:pt>
                <c:pt idx="21">
                  <c:v>1.3764880952380953</c:v>
                </c:pt>
                <c:pt idx="22">
                  <c:v>1.4174668495656151</c:v>
                </c:pt>
                <c:pt idx="23">
                  <c:v>1.4051522249999999</c:v>
                </c:pt>
              </c:numCache>
            </c:numRef>
          </c:val>
        </c:ser>
        <c:ser>
          <c:idx val="12"/>
          <c:order val="12"/>
          <c:tx>
            <c:strRef>
              <c:f>Sheet3!$A$14</c:f>
              <c:strCache>
                <c:ptCount val="1"/>
                <c:pt idx="0">
                  <c:v>Flavobacteriaceae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14:$Y$14</c:f>
              <c:numCache>
                <c:formatCode>General</c:formatCode>
                <c:ptCount val="24"/>
                <c:pt idx="0">
                  <c:v>0.11336440357727673</c:v>
                </c:pt>
                <c:pt idx="1">
                  <c:v>0.10596962204168138</c:v>
                </c:pt>
                <c:pt idx="2">
                  <c:v>0</c:v>
                </c:pt>
                <c:pt idx="3">
                  <c:v>0.86956521739130432</c:v>
                </c:pt>
                <c:pt idx="5">
                  <c:v>3.280993672369346</c:v>
                </c:pt>
                <c:pt idx="6">
                  <c:v>1.9775106630476929</c:v>
                </c:pt>
                <c:pt idx="7">
                  <c:v>3.2879818594104306</c:v>
                </c:pt>
                <c:pt idx="8">
                  <c:v>1.2578616352201257</c:v>
                </c:pt>
                <c:pt idx="9">
                  <c:v>2.5299600532623168</c:v>
                </c:pt>
                <c:pt idx="11">
                  <c:v>5.5050505050505052</c:v>
                </c:pt>
                <c:pt idx="12">
                  <c:v>2.9464285714285716</c:v>
                </c:pt>
                <c:pt idx="13">
                  <c:v>11.532992036405005</c:v>
                </c:pt>
                <c:pt idx="14">
                  <c:v>3.9702233250620349</c:v>
                </c:pt>
                <c:pt idx="15">
                  <c:v>0.14749262499999999</c:v>
                </c:pt>
                <c:pt idx="17">
                  <c:v>0.75935757005577587</c:v>
                </c:pt>
                <c:pt idx="18">
                  <c:v>3.6608863198458574</c:v>
                </c:pt>
                <c:pt idx="19">
                  <c:v>0.77821011673151752</c:v>
                </c:pt>
                <c:pt idx="21">
                  <c:v>0.1984126984126984</c:v>
                </c:pt>
                <c:pt idx="22">
                  <c:v>4.5724737082761771E-2</c:v>
                </c:pt>
                <c:pt idx="23">
                  <c:v>2.1857923499999998</c:v>
                </c:pt>
              </c:numCache>
            </c:numRef>
          </c:val>
        </c:ser>
        <c:ser>
          <c:idx val="13"/>
          <c:order val="13"/>
          <c:tx>
            <c:strRef>
              <c:f>Sheet3!$A$15</c:f>
              <c:strCache>
                <c:ptCount val="1"/>
                <c:pt idx="0">
                  <c:v>Desulfuromonadaceae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15:$Y$15</c:f>
              <c:numCache>
                <c:formatCode>General</c:formatCode>
                <c:ptCount val="24"/>
                <c:pt idx="0">
                  <c:v>0.4408615694671873</c:v>
                </c:pt>
                <c:pt idx="1">
                  <c:v>0.63581773225008831</c:v>
                </c:pt>
                <c:pt idx="2">
                  <c:v>0</c:v>
                </c:pt>
                <c:pt idx="3">
                  <c:v>3.4782608695652173</c:v>
                </c:pt>
                <c:pt idx="5">
                  <c:v>3.023201312397469</c:v>
                </c:pt>
                <c:pt idx="6">
                  <c:v>4.9243892981775881</c:v>
                </c:pt>
                <c:pt idx="7">
                  <c:v>3.0423280423280423</c:v>
                </c:pt>
                <c:pt idx="8">
                  <c:v>0.94339622641509435</c:v>
                </c:pt>
                <c:pt idx="9">
                  <c:v>3.6839769196626722</c:v>
                </c:pt>
                <c:pt idx="11">
                  <c:v>1.5151515151515151</c:v>
                </c:pt>
                <c:pt idx="12">
                  <c:v>2.2767857142857144</c:v>
                </c:pt>
                <c:pt idx="13">
                  <c:v>1.422070534698521</c:v>
                </c:pt>
                <c:pt idx="14">
                  <c:v>1.2406947890818858</c:v>
                </c:pt>
                <c:pt idx="15">
                  <c:v>2.8023598820000002</c:v>
                </c:pt>
                <c:pt idx="17">
                  <c:v>3.2524695920973055</c:v>
                </c:pt>
                <c:pt idx="18">
                  <c:v>0.96339113680154143</c:v>
                </c:pt>
                <c:pt idx="19">
                  <c:v>6.2256809338521402</c:v>
                </c:pt>
                <c:pt idx="21">
                  <c:v>1.7113095238095237</c:v>
                </c:pt>
                <c:pt idx="22">
                  <c:v>0.82304526748971196</c:v>
                </c:pt>
                <c:pt idx="23">
                  <c:v>1.327088212</c:v>
                </c:pt>
              </c:numCache>
            </c:numRef>
          </c:val>
        </c:ser>
        <c:ser>
          <c:idx val="14"/>
          <c:order val="14"/>
          <c:tx>
            <c:strRef>
              <c:f>Sheet3!$A$16</c:f>
              <c:strCache>
                <c:ptCount val="1"/>
                <c:pt idx="0">
                  <c:v>Nocardioidaceae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16:$Y$16</c:f>
              <c:numCache>
                <c:formatCode>General</c:formatCode>
                <c:ptCount val="24"/>
                <c:pt idx="0">
                  <c:v>4.673132636352185</c:v>
                </c:pt>
                <c:pt idx="1">
                  <c:v>3.037795831861533</c:v>
                </c:pt>
                <c:pt idx="2">
                  <c:v>3.1216361679224973</c:v>
                </c:pt>
                <c:pt idx="3">
                  <c:v>3.3540372670807455</c:v>
                </c:pt>
                <c:pt idx="5">
                  <c:v>9.3742676353409896E-2</c:v>
                </c:pt>
                <c:pt idx="6">
                  <c:v>1.1632415664986429</c:v>
                </c:pt>
                <c:pt idx="7">
                  <c:v>9.4482237339380201E-2</c:v>
                </c:pt>
                <c:pt idx="8">
                  <c:v>4.4025157232704402</c:v>
                </c:pt>
                <c:pt idx="9">
                  <c:v>8.8770528184642705E-2</c:v>
                </c:pt>
                <c:pt idx="11">
                  <c:v>0.15151515151515152</c:v>
                </c:pt>
                <c:pt idx="12">
                  <c:v>0.26785714285714285</c:v>
                </c:pt>
                <c:pt idx="13">
                  <c:v>0.19908987485779295</c:v>
                </c:pt>
                <c:pt idx="14">
                  <c:v>1.9851116625310175</c:v>
                </c:pt>
                <c:pt idx="15">
                  <c:v>3.392330383</c:v>
                </c:pt>
                <c:pt idx="17">
                  <c:v>1.8412741079228547</c:v>
                </c:pt>
                <c:pt idx="18">
                  <c:v>3.0828516377649327</c:v>
                </c:pt>
                <c:pt idx="19">
                  <c:v>1.6212710765239948</c:v>
                </c:pt>
                <c:pt idx="21">
                  <c:v>0.52083333333333337</c:v>
                </c:pt>
                <c:pt idx="22">
                  <c:v>3.5665294924554183</c:v>
                </c:pt>
                <c:pt idx="23">
                  <c:v>3.9812646370000002</c:v>
                </c:pt>
              </c:numCache>
            </c:numRef>
          </c:val>
        </c:ser>
        <c:ser>
          <c:idx val="15"/>
          <c:order val="15"/>
          <c:tx>
            <c:strRef>
              <c:f>Sheet3!$A$17</c:f>
              <c:strCache>
                <c:ptCount val="1"/>
                <c:pt idx="0">
                  <c:v>Rhodospirillaceae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17:$Y$17</c:f>
              <c:numCache>
                <c:formatCode>General</c:formatCode>
                <c:ptCount val="24"/>
                <c:pt idx="0">
                  <c:v>1.6500818742914725</c:v>
                </c:pt>
                <c:pt idx="1">
                  <c:v>2.1547156481808547</c:v>
                </c:pt>
                <c:pt idx="2">
                  <c:v>1.3993541442411195</c:v>
                </c:pt>
                <c:pt idx="3">
                  <c:v>3.1055900621118013</c:v>
                </c:pt>
                <c:pt idx="5">
                  <c:v>2.7654089524255916</c:v>
                </c:pt>
                <c:pt idx="6">
                  <c:v>2.0162853819309809</c:v>
                </c:pt>
                <c:pt idx="7">
                  <c:v>2.7777777777777777</c:v>
                </c:pt>
                <c:pt idx="8">
                  <c:v>1.8867924528301887</c:v>
                </c:pt>
                <c:pt idx="9">
                  <c:v>3.1069684864624945</c:v>
                </c:pt>
                <c:pt idx="11">
                  <c:v>1.5151515151515151</c:v>
                </c:pt>
                <c:pt idx="12">
                  <c:v>2.7678571428571428</c:v>
                </c:pt>
                <c:pt idx="13">
                  <c:v>1.3509670079635949</c:v>
                </c:pt>
                <c:pt idx="14">
                  <c:v>1.4888337468982631</c:v>
                </c:pt>
                <c:pt idx="15">
                  <c:v>2.2123893809999999</c:v>
                </c:pt>
                <c:pt idx="17">
                  <c:v>1.2297560647805927</c:v>
                </c:pt>
                <c:pt idx="18">
                  <c:v>2.5048169556840079</c:v>
                </c:pt>
                <c:pt idx="19">
                  <c:v>2.5940337224383918</c:v>
                </c:pt>
                <c:pt idx="21">
                  <c:v>0.44642857142857145</c:v>
                </c:pt>
                <c:pt idx="22">
                  <c:v>0.91449474165523548</c:v>
                </c:pt>
                <c:pt idx="23">
                  <c:v>2.5761124120000001</c:v>
                </c:pt>
              </c:numCache>
            </c:numRef>
          </c:val>
        </c:ser>
        <c:ser>
          <c:idx val="16"/>
          <c:order val="16"/>
          <c:tx>
            <c:strRef>
              <c:f>Sheet3!$A$18</c:f>
              <c:strCache>
                <c:ptCount val="1"/>
                <c:pt idx="0">
                  <c:v>Acetobacteraceae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18:$Y$18</c:f>
              <c:numCache>
                <c:formatCode>General</c:formatCode>
                <c:ptCount val="24"/>
                <c:pt idx="0">
                  <c:v>1.6500818742914725</c:v>
                </c:pt>
                <c:pt idx="1">
                  <c:v>1.412928293889085</c:v>
                </c:pt>
                <c:pt idx="2">
                  <c:v>13.02475780409042</c:v>
                </c:pt>
                <c:pt idx="3">
                  <c:v>0.2484472049689441</c:v>
                </c:pt>
                <c:pt idx="5">
                  <c:v>4.6871338176704948E-2</c:v>
                </c:pt>
                <c:pt idx="6">
                  <c:v>0.15509887553315238</c:v>
                </c:pt>
                <c:pt idx="7">
                  <c:v>0.3779289493575208</c:v>
                </c:pt>
                <c:pt idx="8">
                  <c:v>0.31446540880503143</c:v>
                </c:pt>
                <c:pt idx="9">
                  <c:v>0.31069684864624947</c:v>
                </c:pt>
                <c:pt idx="11">
                  <c:v>7.575757575757576E-2</c:v>
                </c:pt>
                <c:pt idx="12">
                  <c:v>0.17857142857142858</c:v>
                </c:pt>
                <c:pt idx="13">
                  <c:v>0.17064846416382254</c:v>
                </c:pt>
                <c:pt idx="14">
                  <c:v>5.2109181141439205</c:v>
                </c:pt>
                <c:pt idx="15">
                  <c:v>1.032448378</c:v>
                </c:pt>
                <c:pt idx="17">
                  <c:v>0.645117935622606</c:v>
                </c:pt>
                <c:pt idx="18">
                  <c:v>4.4315992292870909</c:v>
                </c:pt>
                <c:pt idx="19">
                  <c:v>1.6212710765239948</c:v>
                </c:pt>
                <c:pt idx="21">
                  <c:v>0.1984126984126984</c:v>
                </c:pt>
                <c:pt idx="22">
                  <c:v>1.2345679012345678</c:v>
                </c:pt>
                <c:pt idx="23">
                  <c:v>0</c:v>
                </c:pt>
              </c:numCache>
            </c:numRef>
          </c:val>
        </c:ser>
        <c:ser>
          <c:idx val="17"/>
          <c:order val="17"/>
          <c:tx>
            <c:strRef>
              <c:f>Sheet3!$A$19</c:f>
              <c:strCache>
                <c:ptCount val="1"/>
                <c:pt idx="0">
                  <c:v>Sphingomonadaceae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19:$Y$19</c:f>
              <c:numCache>
                <c:formatCode>General</c:formatCode>
                <c:ptCount val="24"/>
                <c:pt idx="0">
                  <c:v>0.99508754251165132</c:v>
                </c:pt>
                <c:pt idx="1">
                  <c:v>1.1656658424584951</c:v>
                </c:pt>
                <c:pt idx="2">
                  <c:v>0</c:v>
                </c:pt>
                <c:pt idx="3">
                  <c:v>1.6149068322981366</c:v>
                </c:pt>
                <c:pt idx="5">
                  <c:v>1.8279821888914929</c:v>
                </c:pt>
                <c:pt idx="6">
                  <c:v>1.4734393175649476</c:v>
                </c:pt>
                <c:pt idx="7">
                  <c:v>2.1919879062736207</c:v>
                </c:pt>
                <c:pt idx="8">
                  <c:v>1.2578616352201257</c:v>
                </c:pt>
                <c:pt idx="9">
                  <c:v>2.1304926764314249</c:v>
                </c:pt>
                <c:pt idx="11">
                  <c:v>1.994949494949495</c:v>
                </c:pt>
                <c:pt idx="12">
                  <c:v>1.3839285714285714</c:v>
                </c:pt>
                <c:pt idx="13">
                  <c:v>1.2087599544937428</c:v>
                </c:pt>
                <c:pt idx="14">
                  <c:v>3.225806451612903</c:v>
                </c:pt>
                <c:pt idx="15">
                  <c:v>2.0648967549999999</c:v>
                </c:pt>
                <c:pt idx="17">
                  <c:v>1.2364760432766615</c:v>
                </c:pt>
                <c:pt idx="18">
                  <c:v>1.1560693641618498</c:v>
                </c:pt>
                <c:pt idx="19">
                  <c:v>2.2697795071335927</c:v>
                </c:pt>
                <c:pt idx="21">
                  <c:v>0.27281746031746029</c:v>
                </c:pt>
                <c:pt idx="22">
                  <c:v>0.41152263374485598</c:v>
                </c:pt>
                <c:pt idx="23">
                  <c:v>2.5761124120000001</c:v>
                </c:pt>
              </c:numCache>
            </c:numRef>
          </c:val>
        </c:ser>
        <c:ser>
          <c:idx val="18"/>
          <c:order val="18"/>
          <c:tx>
            <c:strRef>
              <c:f>Sheet3!$A$20</c:f>
              <c:strCache>
                <c:ptCount val="1"/>
                <c:pt idx="0">
                  <c:v>Thiotrichaceae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20:$Y$20</c:f>
              <c:numCache>
                <c:formatCode>General</c:formatCode>
                <c:ptCount val="24"/>
                <c:pt idx="0">
                  <c:v>1.7256581433429903</c:v>
                </c:pt>
                <c:pt idx="1">
                  <c:v>0.95372659837513252</c:v>
                </c:pt>
                <c:pt idx="2">
                  <c:v>1.0764262648008611</c:v>
                </c:pt>
                <c:pt idx="3">
                  <c:v>0.86956521739130432</c:v>
                </c:pt>
                <c:pt idx="5">
                  <c:v>1.687368174361378</c:v>
                </c:pt>
                <c:pt idx="6">
                  <c:v>1.3183404420317952</c:v>
                </c:pt>
                <c:pt idx="7">
                  <c:v>0.43461829176114891</c:v>
                </c:pt>
                <c:pt idx="8">
                  <c:v>1.8867924528301887</c:v>
                </c:pt>
                <c:pt idx="9">
                  <c:v>0.39946737683089212</c:v>
                </c:pt>
                <c:pt idx="11">
                  <c:v>4.0151515151515156</c:v>
                </c:pt>
                <c:pt idx="12">
                  <c:v>2.9464285714285716</c:v>
                </c:pt>
                <c:pt idx="13">
                  <c:v>0.78213879408418663</c:v>
                </c:pt>
                <c:pt idx="14">
                  <c:v>0.99255583126550873</c:v>
                </c:pt>
                <c:pt idx="15">
                  <c:v>0.58997050100000004</c:v>
                </c:pt>
                <c:pt idx="17">
                  <c:v>0.5913581076540555</c:v>
                </c:pt>
                <c:pt idx="18">
                  <c:v>2.8901734104046244</c:v>
                </c:pt>
                <c:pt idx="19">
                  <c:v>0.32425421530479898</c:v>
                </c:pt>
                <c:pt idx="21">
                  <c:v>0.16121031746031747</c:v>
                </c:pt>
                <c:pt idx="22">
                  <c:v>1.4174668495656151</c:v>
                </c:pt>
                <c:pt idx="23">
                  <c:v>1.4051522249999999</c:v>
                </c:pt>
              </c:numCache>
            </c:numRef>
          </c:val>
        </c:ser>
        <c:ser>
          <c:idx val="19"/>
          <c:order val="19"/>
          <c:tx>
            <c:strRef>
              <c:f>Sheet3!$A$21</c:f>
              <c:strCache>
                <c:ptCount val="1"/>
                <c:pt idx="0">
                  <c:v>Rhodocyclaceae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21:$Y$21</c:f>
              <c:numCache>
                <c:formatCode>General</c:formatCode>
                <c:ptCount val="24"/>
                <c:pt idx="0">
                  <c:v>6.461771003904774</c:v>
                </c:pt>
                <c:pt idx="1">
                  <c:v>4.5920169551395267</c:v>
                </c:pt>
                <c:pt idx="2">
                  <c:v>0.10764262648008611</c:v>
                </c:pt>
                <c:pt idx="3">
                  <c:v>1.3664596273291925</c:v>
                </c:pt>
                <c:pt idx="5">
                  <c:v>0.49214905085540195</c:v>
                </c:pt>
                <c:pt idx="6">
                  <c:v>0.27142303218301667</c:v>
                </c:pt>
                <c:pt idx="7">
                  <c:v>0.15117157974300832</c:v>
                </c:pt>
                <c:pt idx="8">
                  <c:v>1.5723270440251573</c:v>
                </c:pt>
                <c:pt idx="9">
                  <c:v>0</c:v>
                </c:pt>
                <c:pt idx="11">
                  <c:v>5.0505050505050504E-2</c:v>
                </c:pt>
                <c:pt idx="12">
                  <c:v>8.9285714285714288E-2</c:v>
                </c:pt>
                <c:pt idx="13">
                  <c:v>2.844141069397042E-2</c:v>
                </c:pt>
                <c:pt idx="14">
                  <c:v>0</c:v>
                </c:pt>
                <c:pt idx="15">
                  <c:v>2.9498525070000001</c:v>
                </c:pt>
                <c:pt idx="17">
                  <c:v>1.4044755056783818</c:v>
                </c:pt>
                <c:pt idx="18">
                  <c:v>0.38535645472061658</c:v>
                </c:pt>
                <c:pt idx="19">
                  <c:v>1.2321660181582361</c:v>
                </c:pt>
                <c:pt idx="21">
                  <c:v>0.1984126984126984</c:v>
                </c:pt>
                <c:pt idx="22">
                  <c:v>3.5208047553726565</c:v>
                </c:pt>
                <c:pt idx="23">
                  <c:v>1.56128025</c:v>
                </c:pt>
              </c:numCache>
            </c:numRef>
          </c:val>
        </c:ser>
        <c:ser>
          <c:idx val="20"/>
          <c:order val="20"/>
          <c:tx>
            <c:strRef>
              <c:f>Sheet3!$A$22</c:f>
              <c:strCache>
                <c:ptCount val="1"/>
                <c:pt idx="0">
                  <c:v>Erythrobacteraceae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22:$Y$22</c:f>
              <c:numCache>
                <c:formatCode>General</c:formatCode>
                <c:ptCount val="24"/>
                <c:pt idx="0">
                  <c:v>1.4737372465045975</c:v>
                </c:pt>
                <c:pt idx="1">
                  <c:v>3.0024726245143061</c:v>
                </c:pt>
                <c:pt idx="2">
                  <c:v>0</c:v>
                </c:pt>
                <c:pt idx="3">
                  <c:v>1.4906832298136645</c:v>
                </c:pt>
                <c:pt idx="5">
                  <c:v>1.687368174361378</c:v>
                </c:pt>
                <c:pt idx="6">
                  <c:v>0.96936797208220238</c:v>
                </c:pt>
                <c:pt idx="7">
                  <c:v>1.2093726379440666</c:v>
                </c:pt>
                <c:pt idx="8">
                  <c:v>2.2012578616352201</c:v>
                </c:pt>
                <c:pt idx="9">
                  <c:v>0.75454948956946288</c:v>
                </c:pt>
                <c:pt idx="11">
                  <c:v>1.0606060606060606</c:v>
                </c:pt>
                <c:pt idx="12">
                  <c:v>0.8482142857142857</c:v>
                </c:pt>
                <c:pt idx="13">
                  <c:v>0.75369738339021619</c:v>
                </c:pt>
                <c:pt idx="14">
                  <c:v>0.99255583126550873</c:v>
                </c:pt>
                <c:pt idx="15">
                  <c:v>1.622418879</c:v>
                </c:pt>
                <c:pt idx="17">
                  <c:v>1.041596666890666</c:v>
                </c:pt>
                <c:pt idx="18">
                  <c:v>1.9267822736030829</c:v>
                </c:pt>
                <c:pt idx="19">
                  <c:v>0.77821011673151752</c:v>
                </c:pt>
                <c:pt idx="21">
                  <c:v>0.11160714285714286</c:v>
                </c:pt>
                <c:pt idx="22">
                  <c:v>9.1449474165523542E-2</c:v>
                </c:pt>
                <c:pt idx="23">
                  <c:v>2.966432475</c:v>
                </c:pt>
              </c:numCache>
            </c:numRef>
          </c:val>
        </c:ser>
        <c:ser>
          <c:idx val="21"/>
          <c:order val="21"/>
          <c:tx>
            <c:strRef>
              <c:f>Sheet3!$A$23</c:f>
              <c:strCache>
                <c:ptCount val="1"/>
                <c:pt idx="0">
                  <c:v>Flammeovirgaceae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23:$Y$23</c:f>
              <c:numCache>
                <c:formatCode>General</c:formatCode>
                <c:ptCount val="24"/>
                <c:pt idx="0">
                  <c:v>0.64239828693790146</c:v>
                </c:pt>
                <c:pt idx="1">
                  <c:v>0.74178735429176967</c:v>
                </c:pt>
                <c:pt idx="2">
                  <c:v>0</c:v>
                </c:pt>
                <c:pt idx="3">
                  <c:v>0.99378881987577639</c:v>
                </c:pt>
                <c:pt idx="5">
                  <c:v>1.6170611670963206</c:v>
                </c:pt>
                <c:pt idx="6">
                  <c:v>1.5897634742148119</c:v>
                </c:pt>
                <c:pt idx="7">
                  <c:v>1.7384731670445956</c:v>
                </c:pt>
                <c:pt idx="8">
                  <c:v>1.5723270440251573</c:v>
                </c:pt>
                <c:pt idx="9">
                  <c:v>1.4647137150466045</c:v>
                </c:pt>
                <c:pt idx="11">
                  <c:v>2.7525252525252526</c:v>
                </c:pt>
                <c:pt idx="12">
                  <c:v>2.5</c:v>
                </c:pt>
                <c:pt idx="13">
                  <c:v>1.5216154721274175</c:v>
                </c:pt>
                <c:pt idx="14">
                  <c:v>0.74441687344913154</c:v>
                </c:pt>
                <c:pt idx="15">
                  <c:v>0.14749262499999999</c:v>
                </c:pt>
                <c:pt idx="17">
                  <c:v>1.2095961292923862</c:v>
                </c:pt>
                <c:pt idx="18">
                  <c:v>1.1560693641618498</c:v>
                </c:pt>
                <c:pt idx="19">
                  <c:v>0.90791180285343709</c:v>
                </c:pt>
                <c:pt idx="21">
                  <c:v>1.6741071428571428</c:v>
                </c:pt>
                <c:pt idx="22">
                  <c:v>0.54869684499314131</c:v>
                </c:pt>
                <c:pt idx="23">
                  <c:v>1.4051522249999999</c:v>
                </c:pt>
              </c:numCache>
            </c:numRef>
          </c:val>
        </c:ser>
        <c:ser>
          <c:idx val="22"/>
          <c:order val="22"/>
          <c:tx>
            <c:strRef>
              <c:f>Sheet3!$A$24</c:f>
              <c:strCache>
                <c:ptCount val="1"/>
                <c:pt idx="0">
                  <c:v>Mycobacteriaceae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24:$Y$24</c:f>
              <c:numCache>
                <c:formatCode>General</c:formatCode>
                <c:ptCount val="24"/>
                <c:pt idx="0">
                  <c:v>1.3477767980854012</c:v>
                </c:pt>
                <c:pt idx="1">
                  <c:v>1.4835747085835393</c:v>
                </c:pt>
                <c:pt idx="2">
                  <c:v>1.9375672766415502</c:v>
                </c:pt>
                <c:pt idx="3">
                  <c:v>1.6149068322981366</c:v>
                </c:pt>
                <c:pt idx="5">
                  <c:v>0.39840637450199201</c:v>
                </c:pt>
                <c:pt idx="6">
                  <c:v>1.1632415664986429</c:v>
                </c:pt>
                <c:pt idx="7">
                  <c:v>0.49130763416477702</c:v>
                </c:pt>
                <c:pt idx="8">
                  <c:v>0.31446540880503143</c:v>
                </c:pt>
                <c:pt idx="9">
                  <c:v>0.39946737683089212</c:v>
                </c:pt>
                <c:pt idx="11">
                  <c:v>2.5252525252525252E-2</c:v>
                </c:pt>
                <c:pt idx="12">
                  <c:v>0.9821428571428571</c:v>
                </c:pt>
                <c:pt idx="13">
                  <c:v>0.66837315130830488</c:v>
                </c:pt>
                <c:pt idx="14">
                  <c:v>0.99255583126550873</c:v>
                </c:pt>
                <c:pt idx="15">
                  <c:v>1.91740413</c:v>
                </c:pt>
                <c:pt idx="17">
                  <c:v>1.4985552046233452</c:v>
                </c:pt>
                <c:pt idx="18">
                  <c:v>0.96339113680154143</c:v>
                </c:pt>
                <c:pt idx="19">
                  <c:v>2.2697795071335927</c:v>
                </c:pt>
                <c:pt idx="21">
                  <c:v>2.8273809523809526</c:v>
                </c:pt>
                <c:pt idx="22">
                  <c:v>0.91449474165523548</c:v>
                </c:pt>
                <c:pt idx="23">
                  <c:v>1.014832162</c:v>
                </c:pt>
              </c:numCache>
            </c:numRef>
          </c:val>
        </c:ser>
        <c:ser>
          <c:idx val="23"/>
          <c:order val="23"/>
          <c:tx>
            <c:strRef>
              <c:f>Sheet3!$A$25</c:f>
              <c:strCache>
                <c:ptCount val="1"/>
                <c:pt idx="0">
                  <c:v>Spirochaetaceae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25:$Y$25</c:f>
              <c:numCache>
                <c:formatCode>General</c:formatCode>
                <c:ptCount val="24"/>
                <c:pt idx="0">
                  <c:v>0.28970903136415166</c:v>
                </c:pt>
                <c:pt idx="1">
                  <c:v>0.52984811020840694</c:v>
                </c:pt>
                <c:pt idx="2">
                  <c:v>0</c:v>
                </c:pt>
                <c:pt idx="3">
                  <c:v>1.1180124223602483</c:v>
                </c:pt>
                <c:pt idx="5">
                  <c:v>1.8045465198031403</c:v>
                </c:pt>
                <c:pt idx="6">
                  <c:v>2.055060100814269</c:v>
                </c:pt>
                <c:pt idx="7">
                  <c:v>1.00151171579743</c:v>
                </c:pt>
                <c:pt idx="8">
                  <c:v>0.94339622641509435</c:v>
                </c:pt>
                <c:pt idx="9">
                  <c:v>0.84332001775410559</c:v>
                </c:pt>
                <c:pt idx="11">
                  <c:v>2.1969696969696968</c:v>
                </c:pt>
                <c:pt idx="12">
                  <c:v>1.9196428571428572</c:v>
                </c:pt>
                <c:pt idx="13">
                  <c:v>1.3509670079635949</c:v>
                </c:pt>
                <c:pt idx="14">
                  <c:v>1.4888337468982631</c:v>
                </c:pt>
                <c:pt idx="15">
                  <c:v>0.58997050100000004</c:v>
                </c:pt>
                <c:pt idx="17">
                  <c:v>1.3708756131980377</c:v>
                </c:pt>
                <c:pt idx="18">
                  <c:v>1.3487475915221581</c:v>
                </c:pt>
                <c:pt idx="19">
                  <c:v>0.58365758754863817</c:v>
                </c:pt>
                <c:pt idx="21">
                  <c:v>1.8973214285714286</c:v>
                </c:pt>
                <c:pt idx="22">
                  <c:v>1.0516689529035208</c:v>
                </c:pt>
                <c:pt idx="23">
                  <c:v>0.62451210000000001</c:v>
                </c:pt>
              </c:numCache>
            </c:numRef>
          </c:val>
        </c:ser>
        <c:ser>
          <c:idx val="24"/>
          <c:order val="24"/>
          <c:tx>
            <c:strRef>
              <c:f>Sheet3!$A$26</c:f>
              <c:strCache>
                <c:ptCount val="1"/>
                <c:pt idx="0">
                  <c:v>Oceanospirillacea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26:$Y$26</c:f>
              <c:numCache>
                <c:formatCode>General</c:formatCode>
                <c:ptCount val="24"/>
                <c:pt idx="0">
                  <c:v>0.11336440357727673</c:v>
                </c:pt>
                <c:pt idx="1">
                  <c:v>0.24726245143058989</c:v>
                </c:pt>
                <c:pt idx="2">
                  <c:v>0</c:v>
                </c:pt>
                <c:pt idx="3">
                  <c:v>1.1180124223602483</c:v>
                </c:pt>
                <c:pt idx="5">
                  <c:v>0.96086243262245141</c:v>
                </c:pt>
                <c:pt idx="6">
                  <c:v>1.240791004265219</c:v>
                </c:pt>
                <c:pt idx="7">
                  <c:v>1.6439909297052153</c:v>
                </c:pt>
                <c:pt idx="8">
                  <c:v>1.5723270440251573</c:v>
                </c:pt>
                <c:pt idx="9">
                  <c:v>2.8850421660008876</c:v>
                </c:pt>
                <c:pt idx="11">
                  <c:v>0.75757575757575757</c:v>
                </c:pt>
                <c:pt idx="12">
                  <c:v>0.625</c:v>
                </c:pt>
                <c:pt idx="13">
                  <c:v>1.1234357224118316</c:v>
                </c:pt>
                <c:pt idx="14">
                  <c:v>0.99255583126550873</c:v>
                </c:pt>
                <c:pt idx="15">
                  <c:v>0.44247787599999999</c:v>
                </c:pt>
                <c:pt idx="17">
                  <c:v>2.083193333781332</c:v>
                </c:pt>
                <c:pt idx="18">
                  <c:v>1.5414258188824663</c:v>
                </c:pt>
                <c:pt idx="19">
                  <c:v>2.0752269779507135</c:v>
                </c:pt>
                <c:pt idx="21">
                  <c:v>0.21081349206349206</c:v>
                </c:pt>
                <c:pt idx="22">
                  <c:v>0.22862368541380887</c:v>
                </c:pt>
                <c:pt idx="23">
                  <c:v>0.70257611200000003</c:v>
                </c:pt>
              </c:numCache>
            </c:numRef>
          </c:val>
        </c:ser>
        <c:ser>
          <c:idx val="25"/>
          <c:order val="25"/>
          <c:tx>
            <c:strRef>
              <c:f>Sheet3!$A$27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1:$Y$1</c:f>
              <c:strCache>
                <c:ptCount val="24"/>
                <c:pt idx="0">
                  <c:v>U1</c:v>
                </c:pt>
                <c:pt idx="1">
                  <c:v>U2</c:v>
                </c:pt>
                <c:pt idx="2">
                  <c:v>U3</c:v>
                </c:pt>
                <c:pt idx="3">
                  <c:v>U4</c:v>
                </c:pt>
                <c:pt idx="5">
                  <c:v>M1</c:v>
                </c:pt>
                <c:pt idx="6">
                  <c:v>M2</c:v>
                </c:pt>
                <c:pt idx="7">
                  <c:v>M3</c:v>
                </c:pt>
                <c:pt idx="8">
                  <c:v>M4</c:v>
                </c:pt>
                <c:pt idx="9">
                  <c:v>M5</c:v>
                </c:pt>
                <c:pt idx="11">
                  <c:v>L1</c:v>
                </c:pt>
                <c:pt idx="12">
                  <c:v>L2</c:v>
                </c:pt>
                <c:pt idx="13">
                  <c:v>L3</c:v>
                </c:pt>
                <c:pt idx="14">
                  <c:v>L4</c:v>
                </c:pt>
                <c:pt idx="15">
                  <c:v>L5</c:v>
                </c:pt>
                <c:pt idx="17">
                  <c:v>B1</c:v>
                </c:pt>
                <c:pt idx="18">
                  <c:v>B2</c:v>
                </c:pt>
                <c:pt idx="19">
                  <c:v>B3</c:v>
                </c:pt>
                <c:pt idx="21">
                  <c:v>D1</c:v>
                </c:pt>
                <c:pt idx="22">
                  <c:v>D2</c:v>
                </c:pt>
                <c:pt idx="23">
                  <c:v>D3</c:v>
                </c:pt>
              </c:strCache>
            </c:strRef>
          </c:cat>
          <c:val>
            <c:numRef>
              <c:f>Sheet3!$B$27:$Y$27</c:f>
              <c:numCache>
                <c:formatCode>General</c:formatCode>
                <c:ptCount val="24"/>
                <c:pt idx="0">
                  <c:v>9.5729940798589013</c:v>
                </c:pt>
                <c:pt idx="1">
                  <c:v>6.6054397739314794</c:v>
                </c:pt>
                <c:pt idx="2">
                  <c:v>24.327233584499467</c:v>
                </c:pt>
                <c:pt idx="3">
                  <c:v>8.9440993788820151</c:v>
                </c:pt>
                <c:pt idx="5">
                  <c:v>10.944457464260594</c:v>
                </c:pt>
                <c:pt idx="6">
                  <c:v>11.826289259402856</c:v>
                </c:pt>
                <c:pt idx="7">
                  <c:v>11.073318216175352</c:v>
                </c:pt>
                <c:pt idx="8">
                  <c:v>10.062893081761004</c:v>
                </c:pt>
                <c:pt idx="9">
                  <c:v>11.140701287172689</c:v>
                </c:pt>
                <c:pt idx="11">
                  <c:v>14.469696969696955</c:v>
                </c:pt>
                <c:pt idx="12">
                  <c:v>13.392857142857153</c:v>
                </c:pt>
                <c:pt idx="13">
                  <c:v>9.0870307167235467</c:v>
                </c:pt>
                <c:pt idx="14">
                  <c:v>11.662531017369744</c:v>
                </c:pt>
                <c:pt idx="15">
                  <c:v>8.2595870220000052</c:v>
                </c:pt>
                <c:pt idx="17">
                  <c:v>12.929238626436387</c:v>
                </c:pt>
                <c:pt idx="18">
                  <c:v>15.992292870905572</c:v>
                </c:pt>
                <c:pt idx="19">
                  <c:v>17.055771725032415</c:v>
                </c:pt>
                <c:pt idx="21">
                  <c:v>9.4866071428571672</c:v>
                </c:pt>
                <c:pt idx="22">
                  <c:v>9.007773205304062</c:v>
                </c:pt>
                <c:pt idx="23">
                  <c:v>10.304449652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27880512"/>
        <c:axId val="2027876704"/>
      </c:barChart>
      <c:catAx>
        <c:axId val="2027880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27876704"/>
        <c:crosses val="autoZero"/>
        <c:auto val="1"/>
        <c:lblAlgn val="ctr"/>
        <c:lblOffset val="100"/>
        <c:noMultiLvlLbl val="0"/>
      </c:catAx>
      <c:valAx>
        <c:axId val="2027876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278805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2!$A$2</c:f>
              <c:strCache>
                <c:ptCount val="1"/>
                <c:pt idx="0">
                  <c:v>Marinilabiacea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2:$O$2</c:f>
              <c:numCache>
                <c:formatCode>General</c:formatCode>
                <c:ptCount val="14"/>
                <c:pt idx="0">
                  <c:v>50.632911392405063</c:v>
                </c:pt>
                <c:pt idx="1">
                  <c:v>32.836710369487484</c:v>
                </c:pt>
                <c:pt idx="2">
                  <c:v>46.025641025641029</c:v>
                </c:pt>
                <c:pt idx="3">
                  <c:v>26.005025125628141</c:v>
                </c:pt>
                <c:pt idx="5">
                  <c:v>40.033898305084747</c:v>
                </c:pt>
                <c:pt idx="6">
                  <c:v>16.791979949874687</c:v>
                </c:pt>
                <c:pt idx="7">
                  <c:v>12.271540469973891</c:v>
                </c:pt>
                <c:pt idx="8">
                  <c:v>23.406040268456376</c:v>
                </c:pt>
                <c:pt idx="10">
                  <c:v>10</c:v>
                </c:pt>
                <c:pt idx="11">
                  <c:v>18.306010928961747</c:v>
                </c:pt>
                <c:pt idx="12">
                  <c:v>22.872702518720217</c:v>
                </c:pt>
                <c:pt idx="13">
                  <c:v>16.04859335038363</c:v>
                </c:pt>
              </c:numCache>
            </c:numRef>
          </c:val>
        </c:ser>
        <c:ser>
          <c:idx val="1"/>
          <c:order val="1"/>
          <c:tx>
            <c:strRef>
              <c:f>Sheet2!$A$3</c:f>
              <c:strCache>
                <c:ptCount val="1"/>
                <c:pt idx="0">
                  <c:v>Pseudoalteromonadacea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3:$O$3</c:f>
              <c:numCache>
                <c:formatCode>General</c:formatCode>
                <c:ptCount val="14"/>
                <c:pt idx="0">
                  <c:v>9.1244725738396628</c:v>
                </c:pt>
                <c:pt idx="1">
                  <c:v>14.451728247914184</c:v>
                </c:pt>
                <c:pt idx="2">
                  <c:v>11.153846153846153</c:v>
                </c:pt>
                <c:pt idx="3">
                  <c:v>3.391959798994975</c:v>
                </c:pt>
                <c:pt idx="5">
                  <c:v>17.525423728813561</c:v>
                </c:pt>
                <c:pt idx="6">
                  <c:v>11.528822055137844</c:v>
                </c:pt>
                <c:pt idx="7">
                  <c:v>42.558746736292427</c:v>
                </c:pt>
                <c:pt idx="8">
                  <c:v>2.6006711409395975</c:v>
                </c:pt>
                <c:pt idx="10">
                  <c:v>0</c:v>
                </c:pt>
                <c:pt idx="11">
                  <c:v>24.590163934426229</c:v>
                </c:pt>
                <c:pt idx="12">
                  <c:v>12.253233492171546</c:v>
                </c:pt>
                <c:pt idx="13">
                  <c:v>8.9514066496163682</c:v>
                </c:pt>
              </c:numCache>
            </c:numRef>
          </c:val>
        </c:ser>
        <c:ser>
          <c:idx val="2"/>
          <c:order val="2"/>
          <c:tx>
            <c:strRef>
              <c:f>Sheet2!$A$4</c:f>
              <c:strCache>
                <c:ptCount val="1"/>
                <c:pt idx="0">
                  <c:v>Lachnospiracea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4:$O$4</c:f>
              <c:numCache>
                <c:formatCode>General</c:formatCode>
                <c:ptCount val="14"/>
                <c:pt idx="0">
                  <c:v>1.7932489451476794</c:v>
                </c:pt>
                <c:pt idx="1">
                  <c:v>23.71871275327771</c:v>
                </c:pt>
                <c:pt idx="2">
                  <c:v>11.410256410256411</c:v>
                </c:pt>
                <c:pt idx="3">
                  <c:v>40.954773869346731</c:v>
                </c:pt>
                <c:pt idx="5">
                  <c:v>0.5423728813559322</c:v>
                </c:pt>
                <c:pt idx="6">
                  <c:v>0.75187969924812026</c:v>
                </c:pt>
                <c:pt idx="7">
                  <c:v>7.3107049608355092</c:v>
                </c:pt>
                <c:pt idx="8">
                  <c:v>56.375838926174495</c:v>
                </c:pt>
                <c:pt idx="10">
                  <c:v>0</c:v>
                </c:pt>
                <c:pt idx="11">
                  <c:v>1.0928961748633881</c:v>
                </c:pt>
                <c:pt idx="12">
                  <c:v>0.27229407760381213</c:v>
                </c:pt>
                <c:pt idx="13">
                  <c:v>0.1918158567774936</c:v>
                </c:pt>
              </c:numCache>
            </c:numRef>
          </c:val>
        </c:ser>
        <c:ser>
          <c:idx val="3"/>
          <c:order val="3"/>
          <c:tx>
            <c:strRef>
              <c:f>Sheet2!$A$5</c:f>
              <c:strCache>
                <c:ptCount val="1"/>
                <c:pt idx="0">
                  <c:v>Flavobacteriacea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5:$O$5</c:f>
              <c:numCache>
                <c:formatCode>General</c:formatCode>
                <c:ptCount val="14"/>
                <c:pt idx="0">
                  <c:v>1.1603375527426161</c:v>
                </c:pt>
                <c:pt idx="1">
                  <c:v>1.162097735399285</c:v>
                </c:pt>
                <c:pt idx="2">
                  <c:v>0.38461538461538464</c:v>
                </c:pt>
                <c:pt idx="3">
                  <c:v>0.12562814070351758</c:v>
                </c:pt>
                <c:pt idx="5">
                  <c:v>9.7288135593220346</c:v>
                </c:pt>
                <c:pt idx="6">
                  <c:v>10.025062656641603</c:v>
                </c:pt>
                <c:pt idx="7">
                  <c:v>8.6161879895561366</c:v>
                </c:pt>
                <c:pt idx="8">
                  <c:v>8.3892617449664433E-2</c:v>
                </c:pt>
                <c:pt idx="10">
                  <c:v>13.478260869565217</c:v>
                </c:pt>
                <c:pt idx="11">
                  <c:v>12.021857923497267</c:v>
                </c:pt>
                <c:pt idx="12">
                  <c:v>38.665759019741323</c:v>
                </c:pt>
                <c:pt idx="13">
                  <c:v>20.076726342710998</c:v>
                </c:pt>
              </c:numCache>
            </c:numRef>
          </c:val>
        </c:ser>
        <c:ser>
          <c:idx val="4"/>
          <c:order val="4"/>
          <c:tx>
            <c:strRef>
              <c:f>Sheet2!$A$6</c:f>
              <c:strCache>
                <c:ptCount val="1"/>
                <c:pt idx="0">
                  <c:v>Rhodobacteracea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6:$O$6</c:f>
              <c:numCache>
                <c:formatCode>General</c:formatCode>
                <c:ptCount val="14"/>
                <c:pt idx="0">
                  <c:v>1.8459915611814346</c:v>
                </c:pt>
                <c:pt idx="1">
                  <c:v>0.41716328963051252</c:v>
                </c:pt>
                <c:pt idx="2">
                  <c:v>0.76923076923076927</c:v>
                </c:pt>
                <c:pt idx="3">
                  <c:v>11.93467336683417</c:v>
                </c:pt>
                <c:pt idx="5">
                  <c:v>3.7966101694915255</c:v>
                </c:pt>
                <c:pt idx="6">
                  <c:v>11.027568922305765</c:v>
                </c:pt>
                <c:pt idx="7">
                  <c:v>0.26109660574412535</c:v>
                </c:pt>
                <c:pt idx="8">
                  <c:v>3.0201342281879193</c:v>
                </c:pt>
                <c:pt idx="10">
                  <c:v>20.869565217391305</c:v>
                </c:pt>
                <c:pt idx="11">
                  <c:v>6.0109289617486334</c:v>
                </c:pt>
                <c:pt idx="12">
                  <c:v>4.7651463580667119</c:v>
                </c:pt>
                <c:pt idx="13">
                  <c:v>11.70076726342711</c:v>
                </c:pt>
              </c:numCache>
            </c:numRef>
          </c:val>
        </c:ser>
        <c:ser>
          <c:idx val="5"/>
          <c:order val="5"/>
          <c:tx>
            <c:strRef>
              <c:f>Sheet2!$A$7</c:f>
              <c:strCache>
                <c:ptCount val="1"/>
                <c:pt idx="0">
                  <c:v>Alteromonadacea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7:$O$7</c:f>
              <c:numCache>
                <c:formatCode>General</c:formatCode>
                <c:ptCount val="14"/>
                <c:pt idx="0">
                  <c:v>0.52742616033755274</c:v>
                </c:pt>
                <c:pt idx="1">
                  <c:v>0.47675804529201432</c:v>
                </c:pt>
                <c:pt idx="2">
                  <c:v>0.51282051282051277</c:v>
                </c:pt>
                <c:pt idx="3">
                  <c:v>0.12562814070351758</c:v>
                </c:pt>
                <c:pt idx="5">
                  <c:v>8.5084745762711869</c:v>
                </c:pt>
                <c:pt idx="6">
                  <c:v>19.047619047619047</c:v>
                </c:pt>
                <c:pt idx="7">
                  <c:v>0.52219321148825071</c:v>
                </c:pt>
                <c:pt idx="8">
                  <c:v>0</c:v>
                </c:pt>
                <c:pt idx="10">
                  <c:v>27.391304347826086</c:v>
                </c:pt>
                <c:pt idx="11">
                  <c:v>0.81967213114754101</c:v>
                </c:pt>
                <c:pt idx="12">
                  <c:v>5.5820285908781484</c:v>
                </c:pt>
                <c:pt idx="13">
                  <c:v>8.8235294117647065</c:v>
                </c:pt>
              </c:numCache>
            </c:numRef>
          </c:val>
        </c:ser>
        <c:ser>
          <c:idx val="6"/>
          <c:order val="6"/>
          <c:tx>
            <c:strRef>
              <c:f>Sheet2!$A$8</c:f>
              <c:strCache>
                <c:ptCount val="1"/>
                <c:pt idx="0">
                  <c:v>Vibrionaceae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8:$O$8</c:f>
              <c:numCache>
                <c:formatCode>General</c:formatCode>
                <c:ptCount val="14"/>
                <c:pt idx="0">
                  <c:v>11.814345991561181</c:v>
                </c:pt>
                <c:pt idx="1">
                  <c:v>12.336114421930871</c:v>
                </c:pt>
                <c:pt idx="2">
                  <c:v>12.435897435897436</c:v>
                </c:pt>
                <c:pt idx="3">
                  <c:v>0.87939698492462315</c:v>
                </c:pt>
                <c:pt idx="5">
                  <c:v>3.2203389830508473</c:v>
                </c:pt>
                <c:pt idx="6">
                  <c:v>1.5037593984962405</c:v>
                </c:pt>
                <c:pt idx="7">
                  <c:v>3.6553524804177546</c:v>
                </c:pt>
                <c:pt idx="8">
                  <c:v>0.75503355704697983</c:v>
                </c:pt>
                <c:pt idx="10">
                  <c:v>0</c:v>
                </c:pt>
                <c:pt idx="11">
                  <c:v>3.278688524590164</c:v>
                </c:pt>
                <c:pt idx="12">
                  <c:v>4.0163376446562289</c:v>
                </c:pt>
                <c:pt idx="13">
                  <c:v>3.9002557544757033</c:v>
                </c:pt>
              </c:numCache>
            </c:numRef>
          </c:val>
        </c:ser>
        <c:ser>
          <c:idx val="7"/>
          <c:order val="7"/>
          <c:tx>
            <c:strRef>
              <c:f>Sheet2!$A$9</c:f>
              <c:strCache>
                <c:ptCount val="1"/>
                <c:pt idx="0">
                  <c:v>Demequinaceae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9:$O$9</c:f>
              <c:numCache>
                <c:formatCode>General</c:formatCode>
                <c:ptCount val="14"/>
                <c:pt idx="0">
                  <c:v>2.3734177215189876</c:v>
                </c:pt>
                <c:pt idx="1">
                  <c:v>2.3539928486293205</c:v>
                </c:pt>
                <c:pt idx="2">
                  <c:v>2.6923076923076925</c:v>
                </c:pt>
                <c:pt idx="3">
                  <c:v>6.5326633165829149</c:v>
                </c:pt>
                <c:pt idx="5">
                  <c:v>1.4915254237288136</c:v>
                </c:pt>
                <c:pt idx="6">
                  <c:v>4.7619047619047619</c:v>
                </c:pt>
                <c:pt idx="7">
                  <c:v>0.78328981723237601</c:v>
                </c:pt>
                <c:pt idx="8">
                  <c:v>8.8926174496644297</c:v>
                </c:pt>
                <c:pt idx="10">
                  <c:v>4.7826086956521738</c:v>
                </c:pt>
                <c:pt idx="11">
                  <c:v>2.7322404371584699</c:v>
                </c:pt>
                <c:pt idx="12">
                  <c:v>0.81688223281143635</c:v>
                </c:pt>
                <c:pt idx="13">
                  <c:v>9.5268542199488486</c:v>
                </c:pt>
              </c:numCache>
            </c:numRef>
          </c:val>
        </c:ser>
        <c:ser>
          <c:idx val="8"/>
          <c:order val="8"/>
          <c:tx>
            <c:strRef>
              <c:f>Sheet2!$A$10</c:f>
              <c:strCache>
                <c:ptCount val="1"/>
                <c:pt idx="0">
                  <c:v>Shewanellaceae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10:$O$10</c:f>
              <c:numCache>
                <c:formatCode>General</c:formatCode>
                <c:ptCount val="14"/>
                <c:pt idx="0">
                  <c:v>0.94936708860759489</c:v>
                </c:pt>
                <c:pt idx="1">
                  <c:v>4.022646007151371</c:v>
                </c:pt>
                <c:pt idx="2">
                  <c:v>3.4615384615384617</c:v>
                </c:pt>
                <c:pt idx="3">
                  <c:v>1.3819095477386936</c:v>
                </c:pt>
                <c:pt idx="5">
                  <c:v>0.13559322033898305</c:v>
                </c:pt>
                <c:pt idx="6">
                  <c:v>0.50125313283208017</c:v>
                </c:pt>
                <c:pt idx="7">
                  <c:v>8.0939947780678843</c:v>
                </c:pt>
                <c:pt idx="8">
                  <c:v>0.25167785234899331</c:v>
                </c:pt>
                <c:pt idx="10">
                  <c:v>0</c:v>
                </c:pt>
                <c:pt idx="11">
                  <c:v>11.202185792349727</c:v>
                </c:pt>
                <c:pt idx="12">
                  <c:v>1.2253233492171545</c:v>
                </c:pt>
                <c:pt idx="13">
                  <c:v>0.25575447570332482</c:v>
                </c:pt>
              </c:numCache>
            </c:numRef>
          </c:val>
        </c:ser>
        <c:ser>
          <c:idx val="9"/>
          <c:order val="9"/>
          <c:tx>
            <c:strRef>
              <c:f>Sheet2!$A$11</c:f>
              <c:strCache>
                <c:ptCount val="1"/>
                <c:pt idx="0">
                  <c:v>Spirochaetaceae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11:$O$11</c:f>
              <c:numCache>
                <c:formatCode>General</c:formatCode>
                <c:ptCount val="14"/>
                <c:pt idx="0">
                  <c:v>7.7004219409282699</c:v>
                </c:pt>
                <c:pt idx="1">
                  <c:v>3.8438617401668651</c:v>
                </c:pt>
                <c:pt idx="2">
                  <c:v>5.2564102564102564</c:v>
                </c:pt>
                <c:pt idx="3">
                  <c:v>0</c:v>
                </c:pt>
                <c:pt idx="5">
                  <c:v>1.3898305084745763</c:v>
                </c:pt>
                <c:pt idx="6">
                  <c:v>0.50125313283208017</c:v>
                </c:pt>
                <c:pt idx="7">
                  <c:v>1.3054830287206267</c:v>
                </c:pt>
                <c:pt idx="8">
                  <c:v>1.174496644295302</c:v>
                </c:pt>
                <c:pt idx="10">
                  <c:v>0</c:v>
                </c:pt>
                <c:pt idx="11">
                  <c:v>0</c:v>
                </c:pt>
                <c:pt idx="12">
                  <c:v>0.68073519400953031</c:v>
                </c:pt>
                <c:pt idx="13">
                  <c:v>0.70332480818414322</c:v>
                </c:pt>
              </c:numCache>
            </c:numRef>
          </c:val>
        </c:ser>
        <c:ser>
          <c:idx val="10"/>
          <c:order val="10"/>
          <c:tx>
            <c:strRef>
              <c:f>Sheet2!$A$12</c:f>
              <c:strCache>
                <c:ptCount val="1"/>
                <c:pt idx="0">
                  <c:v>Desulfobulbaceae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12:$O$12</c:f>
              <c:numCache>
                <c:formatCode>General</c:formatCode>
                <c:ptCount val="14"/>
                <c:pt idx="0">
                  <c:v>2.4789029535864979</c:v>
                </c:pt>
                <c:pt idx="1">
                  <c:v>1.0131108462455305</c:v>
                </c:pt>
                <c:pt idx="2">
                  <c:v>0.76923076923076927</c:v>
                </c:pt>
                <c:pt idx="3">
                  <c:v>2.0100502512562812</c:v>
                </c:pt>
                <c:pt idx="5">
                  <c:v>1.0508474576271187</c:v>
                </c:pt>
                <c:pt idx="6">
                  <c:v>0.25062656641604009</c:v>
                </c:pt>
                <c:pt idx="7">
                  <c:v>5.4830287206266322</c:v>
                </c:pt>
                <c:pt idx="8">
                  <c:v>0.16778523489932887</c:v>
                </c:pt>
                <c:pt idx="10">
                  <c:v>0</c:v>
                </c:pt>
                <c:pt idx="11">
                  <c:v>0.81967213114754101</c:v>
                </c:pt>
                <c:pt idx="12">
                  <c:v>6.8073519400953034E-2</c:v>
                </c:pt>
                <c:pt idx="13">
                  <c:v>2.3017902813299234</c:v>
                </c:pt>
              </c:numCache>
            </c:numRef>
          </c:val>
        </c:ser>
        <c:ser>
          <c:idx val="11"/>
          <c:order val="11"/>
          <c:tx>
            <c:strRef>
              <c:f>Sheet2!$A$13</c:f>
              <c:strCache>
                <c:ptCount val="1"/>
                <c:pt idx="0">
                  <c:v>Bacteriovoracaceae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13:$O$13</c:f>
              <c:numCache>
                <c:formatCode>General</c:formatCode>
                <c:ptCount val="14"/>
                <c:pt idx="0">
                  <c:v>0.10548523206751055</c:v>
                </c:pt>
                <c:pt idx="1">
                  <c:v>0.23837902264600716</c:v>
                </c:pt>
                <c:pt idx="2">
                  <c:v>0</c:v>
                </c:pt>
                <c:pt idx="3">
                  <c:v>0</c:v>
                </c:pt>
                <c:pt idx="5">
                  <c:v>0.64406779661016944</c:v>
                </c:pt>
                <c:pt idx="6">
                  <c:v>2.5062656641604009</c:v>
                </c:pt>
                <c:pt idx="7">
                  <c:v>0</c:v>
                </c:pt>
                <c:pt idx="8">
                  <c:v>0</c:v>
                </c:pt>
                <c:pt idx="10">
                  <c:v>1.3043478260869565</c:v>
                </c:pt>
                <c:pt idx="11">
                  <c:v>9.5628415300546443</c:v>
                </c:pt>
                <c:pt idx="12">
                  <c:v>0.95302927161334239</c:v>
                </c:pt>
                <c:pt idx="13">
                  <c:v>0.95907928388746799</c:v>
                </c:pt>
              </c:numCache>
            </c:numRef>
          </c:val>
        </c:ser>
        <c:ser>
          <c:idx val="12"/>
          <c:order val="12"/>
          <c:tx>
            <c:strRef>
              <c:f>Sheet2!$A$14</c:f>
              <c:strCache>
                <c:ptCount val="1"/>
                <c:pt idx="0">
                  <c:v>Flammeovirgaceae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14:$O$14</c:f>
              <c:numCache>
                <c:formatCode>General</c:formatCode>
                <c:ptCount val="14"/>
                <c:pt idx="0">
                  <c:v>5.2742616033755275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5">
                  <c:v>1.0847457627118644</c:v>
                </c:pt>
                <c:pt idx="6">
                  <c:v>4.0100250626566414</c:v>
                </c:pt>
                <c:pt idx="7">
                  <c:v>0.52219321148825071</c:v>
                </c:pt>
                <c:pt idx="8">
                  <c:v>0</c:v>
                </c:pt>
                <c:pt idx="10">
                  <c:v>5.2173913043478262</c:v>
                </c:pt>
                <c:pt idx="11">
                  <c:v>0</c:v>
                </c:pt>
                <c:pt idx="12">
                  <c:v>0</c:v>
                </c:pt>
                <c:pt idx="13">
                  <c:v>4.0281329923273654</c:v>
                </c:pt>
              </c:numCache>
            </c:numRef>
          </c:val>
        </c:ser>
        <c:ser>
          <c:idx val="13"/>
          <c:order val="13"/>
          <c:tx>
            <c:strRef>
              <c:f>Sheet2!$A$15</c:f>
              <c:strCache>
                <c:ptCount val="1"/>
                <c:pt idx="0">
                  <c:v>Oceanospirillaceae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15:$O$15</c:f>
              <c:numCache>
                <c:formatCode>General</c:formatCode>
                <c:ptCount val="14"/>
                <c:pt idx="0">
                  <c:v>6.2763713080168779</c:v>
                </c:pt>
                <c:pt idx="1">
                  <c:v>0.74493444576877232</c:v>
                </c:pt>
                <c:pt idx="2">
                  <c:v>3.3333333333333335</c:v>
                </c:pt>
                <c:pt idx="3">
                  <c:v>0</c:v>
                </c:pt>
                <c:pt idx="5">
                  <c:v>0.9152542372881356</c:v>
                </c:pt>
                <c:pt idx="6">
                  <c:v>1.0025062656641603</c:v>
                </c:pt>
                <c:pt idx="7">
                  <c:v>0</c:v>
                </c:pt>
                <c:pt idx="8">
                  <c:v>0</c:v>
                </c:pt>
                <c:pt idx="10">
                  <c:v>0.43478260869565216</c:v>
                </c:pt>
                <c:pt idx="11">
                  <c:v>0</c:v>
                </c:pt>
                <c:pt idx="12">
                  <c:v>6.8073519400953034E-2</c:v>
                </c:pt>
                <c:pt idx="13">
                  <c:v>0.12787723785166241</c:v>
                </c:pt>
              </c:numCache>
            </c:numRef>
          </c:val>
        </c:ser>
        <c:ser>
          <c:idx val="14"/>
          <c:order val="14"/>
          <c:tx>
            <c:strRef>
              <c:f>Sheet2!$A$16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:$O$1</c:f>
              <c:strCache>
                <c:ptCount val="14"/>
                <c:pt idx="0">
                  <c:v>NS1</c:v>
                </c:pt>
                <c:pt idx="1">
                  <c:v>NS2</c:v>
                </c:pt>
                <c:pt idx="2">
                  <c:v>NS3</c:v>
                </c:pt>
                <c:pt idx="3">
                  <c:v>NS4</c:v>
                </c:pt>
                <c:pt idx="5">
                  <c:v>EV1</c:v>
                </c:pt>
                <c:pt idx="6">
                  <c:v>EV2</c:v>
                </c:pt>
                <c:pt idx="7">
                  <c:v>EV3</c:v>
                </c:pt>
                <c:pt idx="8">
                  <c:v>EV4</c:v>
                </c:pt>
                <c:pt idx="10">
                  <c:v>PI1</c:v>
                </c:pt>
                <c:pt idx="11">
                  <c:v>PI2</c:v>
                </c:pt>
                <c:pt idx="12">
                  <c:v>PI3</c:v>
                </c:pt>
                <c:pt idx="13">
                  <c:v>PI4</c:v>
                </c:pt>
              </c:strCache>
            </c:strRef>
          </c:cat>
          <c:val>
            <c:numRef>
              <c:f>Sheet2!$B$16:$O$16</c:f>
              <c:numCache>
                <c:formatCode>General</c:formatCode>
                <c:ptCount val="14"/>
                <c:pt idx="0">
                  <c:v>3.1645569620253013</c:v>
                </c:pt>
                <c:pt idx="1">
                  <c:v>2.3837902264600785</c:v>
                </c:pt>
                <c:pt idx="2">
                  <c:v>1.7948717948717956</c:v>
                </c:pt>
                <c:pt idx="3">
                  <c:v>6.6582914572864382</c:v>
                </c:pt>
                <c:pt idx="5">
                  <c:v>9.9322033898304909</c:v>
                </c:pt>
                <c:pt idx="6">
                  <c:v>15.789473684210535</c:v>
                </c:pt>
                <c:pt idx="7">
                  <c:v>8.61618798955611</c:v>
                </c:pt>
                <c:pt idx="8">
                  <c:v>3.2718120805369182</c:v>
                </c:pt>
                <c:pt idx="10">
                  <c:v>16.521739130434781</c:v>
                </c:pt>
                <c:pt idx="11">
                  <c:v>9.5628415300546692</c:v>
                </c:pt>
                <c:pt idx="12">
                  <c:v>7.7603812117086335</c:v>
                </c:pt>
                <c:pt idx="13">
                  <c:v>12.4040920716112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27879968"/>
        <c:axId val="2027875072"/>
      </c:barChart>
      <c:catAx>
        <c:axId val="2027879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27875072"/>
        <c:crosses val="autoZero"/>
        <c:auto val="1"/>
        <c:lblAlgn val="ctr"/>
        <c:lblOffset val="100"/>
        <c:noMultiLvlLbl val="0"/>
      </c:catAx>
      <c:valAx>
        <c:axId val="2027875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278799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3880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1793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82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548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2393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5164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4817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8884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0624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4836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2770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95AEDB-95A4-4989-A69A-47E00FDB4B1B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2C918-CB70-497F-ACEC-24D042D1A3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8558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854382"/>
              </p:ext>
            </p:extLst>
          </p:nvPr>
        </p:nvGraphicFramePr>
        <p:xfrm>
          <a:off x="674255" y="960581"/>
          <a:ext cx="7989454" cy="48029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正方形/長方形 4"/>
          <p:cNvSpPr/>
          <p:nvPr/>
        </p:nvSpPr>
        <p:spPr>
          <a:xfrm>
            <a:off x="6375400" y="6455594"/>
            <a:ext cx="26924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41479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8841293"/>
              </p:ext>
            </p:extLst>
          </p:nvPr>
        </p:nvGraphicFramePr>
        <p:xfrm>
          <a:off x="1394691" y="1209963"/>
          <a:ext cx="6890327" cy="44426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正方形/長方形 5"/>
          <p:cNvSpPr/>
          <p:nvPr/>
        </p:nvSpPr>
        <p:spPr>
          <a:xfrm>
            <a:off x="6375400" y="6455594"/>
            <a:ext cx="26924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9983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</Words>
  <Application>Microsoft Office PowerPoint</Application>
  <PresentationFormat>画面に合わせる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Owner</cp:lastModifiedBy>
  <cp:revision>3</cp:revision>
  <dcterms:created xsi:type="dcterms:W3CDTF">2021-06-05T08:31:06Z</dcterms:created>
  <dcterms:modified xsi:type="dcterms:W3CDTF">2021-10-27T01:12:28Z</dcterms:modified>
</cp:coreProperties>
</file>